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5927C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>
      <p:cViewPr varScale="1">
        <p:scale>
          <a:sx n="86" d="100"/>
          <a:sy n="86" d="100"/>
        </p:scale>
        <p:origin x="84" y="46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AD19CFC4-408E-E8DC-E19E-FC91E76CCC4F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A9C0D48D-5A54-5683-7075-2EDF74F32DB7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D909F233-EDD6-8C91-6642-6FD2F78ECD6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20305B-839B-4863-9916-700E30FA83C5}" type="datetimeFigureOut">
              <a:rPr lang="zh-CN" altLang="en-US" smtClean="0"/>
              <a:t>2025/3/7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64D07D9D-0D18-77A1-3312-900CAAEE683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F45C90E2-8DC7-72BE-38ED-ABAD56C6ED8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E8C46C-210E-4986-8B21-85BBBC61F08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0673723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EF5C7752-A0CB-B039-DB69-9560260CBD7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2790D452-0563-A8BE-491F-F60C9281756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A65B789B-5988-4DBC-6249-8D5CE4C2E76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20305B-839B-4863-9916-700E30FA83C5}" type="datetimeFigureOut">
              <a:rPr lang="zh-CN" altLang="en-US" smtClean="0"/>
              <a:t>2025/3/7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5CF4BE52-03BA-1994-0728-92177E24984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B1CAD754-291D-3822-5660-60C0EB21AE0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E8C46C-210E-4986-8B21-85BBBC61F08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9388097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9163919F-4FA2-BF23-A345-09755A04B75B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56E8945B-3C68-9F09-3D0F-1BAA8F605A9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B2975693-56B7-3526-0F3E-A8EB471A495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20305B-839B-4863-9916-700E30FA83C5}" type="datetimeFigureOut">
              <a:rPr lang="zh-CN" altLang="en-US" smtClean="0"/>
              <a:t>2025/3/7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E8EC908A-38FB-8904-EC5C-F9494C20327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2A3D9A4D-7DD6-336F-FC0C-F16C7876297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E8C46C-210E-4986-8B21-85BBBC61F08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6607131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C7E4D509-BE9E-9AAB-0569-D809CDFA2B4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D611399A-B931-D499-E56A-E7946E59D408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F5D9C8C0-CBC1-21BC-0303-E64A3D8CC86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20305B-839B-4863-9916-700E30FA83C5}" type="datetimeFigureOut">
              <a:rPr lang="zh-CN" altLang="en-US" smtClean="0"/>
              <a:t>2025/3/7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75340E61-33F6-F6B5-E623-3DEF418548B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1E86C477-B0C9-2EB9-3510-82C5CBDFDF6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E8C46C-210E-4986-8B21-85BBBC61F08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87682326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AC664945-957D-54D2-6AED-719FA815E8C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25A426E2-63DD-F72F-1254-57616D6A020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D9259345-0F27-1E1B-0DFA-2746F6BF65A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20305B-839B-4863-9916-700E30FA83C5}" type="datetimeFigureOut">
              <a:rPr lang="zh-CN" altLang="en-US" smtClean="0"/>
              <a:t>2025/3/7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88CC4C47-E8F2-A949-839A-F9A3763141C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47C85E41-67C9-118E-D4E1-FDBDF8059DD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E8C46C-210E-4986-8B21-85BBBC61F08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81901148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FDA9C3F4-685B-0A4D-1B98-A7C35D1CB07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DC2ABC12-856D-43E6-0C4A-785F20FD8FB1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1937758C-9EE0-C356-475E-E61CE38F4B5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B81FC6F6-5BC7-FD9A-2BEF-88698410552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20305B-839B-4863-9916-700E30FA83C5}" type="datetimeFigureOut">
              <a:rPr lang="zh-CN" altLang="en-US" smtClean="0"/>
              <a:t>2025/3/7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FD6127E5-C5B8-B5CD-8B7C-B886BB536D6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0051F692-4DE2-DD5D-BA5C-50C08995FAE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E8C46C-210E-4986-8B21-85BBBC61F08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611031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22853604-A7B2-2F19-5682-6DC9773EF58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404671D9-B460-CAF6-FEB9-BA393876350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9A56C7EF-1929-6F4F-D188-4A92FB46EC1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C8E6EBD0-7989-6530-5E1E-F680DE97DDD2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10C5F9DF-5A7F-49B0-9A08-A1121F05A5E2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F6C3C857-2C9B-396F-340F-8CA12105076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20305B-839B-4863-9916-700E30FA83C5}" type="datetimeFigureOut">
              <a:rPr lang="zh-CN" altLang="en-US" smtClean="0"/>
              <a:t>2025/3/7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536D95D8-A031-BC14-A9B8-8D3C7FF5410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EC48B98F-B0B2-9CF5-DD08-17E0DDD22A4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E8C46C-210E-4986-8B21-85BBBC61F08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4805732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6EC05F98-F175-CFBC-9CD2-C2316623171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4F4F26C1-6B33-8B37-EC17-5C4C1EC918F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20305B-839B-4863-9916-700E30FA83C5}" type="datetimeFigureOut">
              <a:rPr lang="zh-CN" altLang="en-US" smtClean="0"/>
              <a:t>2025/3/7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31F41543-B19B-5878-4EB8-59157D4A48C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073E3AA9-E870-4984-2BB5-994AE292802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E8C46C-210E-4986-8B21-85BBBC61F08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8822937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D7D6BD9C-CF32-C13F-C3B2-3D6F1B12DB3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20305B-839B-4863-9916-700E30FA83C5}" type="datetimeFigureOut">
              <a:rPr lang="zh-CN" altLang="en-US" smtClean="0"/>
              <a:t>2025/3/7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9FD47E6F-292F-52D9-6CBB-E7684C32A1E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361459B9-831A-1D36-884B-0CE0E1BA6AB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E8C46C-210E-4986-8B21-85BBBC61F08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339350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628D7A39-48FD-930C-4760-56491742714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EFBE54D6-4780-83A9-4D65-7B2863F83FB7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77E59E80-A8CC-D07F-0080-F2B816E742F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E553BADC-4D38-E7D9-7167-F6157CD2D16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20305B-839B-4863-9916-700E30FA83C5}" type="datetimeFigureOut">
              <a:rPr lang="zh-CN" altLang="en-US" smtClean="0"/>
              <a:t>2025/3/7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7BB9949F-9BA0-4062-FCC9-0A77284391E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DFF492A7-38A2-347E-EC19-BFDC3FF0C74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E8C46C-210E-4986-8B21-85BBBC61F08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7400915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9E930FB3-1CF5-42AA-D351-CDB0818CEF0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C813DD32-10AE-63D6-763E-DF2D93595326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0A288BCD-093F-D5A2-8356-42AD8176912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E1CDE90A-48A6-9A4C-DB1E-80ED7AD3BF2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20305B-839B-4863-9916-700E30FA83C5}" type="datetimeFigureOut">
              <a:rPr lang="zh-CN" altLang="en-US" smtClean="0"/>
              <a:t>2025/3/7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2438985B-C6B8-48EB-F205-113D3618BA6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1EC59552-C682-729F-1CD2-7952FAB9974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E8C46C-210E-4986-8B21-85BBBC61F08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6053722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1D280D35-2293-3FBB-29A0-D558F203676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3894AA8A-DF1C-5506-D3D2-F1766C75AF5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A1DA346B-9657-D66E-1A42-143E48FD03A0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720305B-839B-4863-9916-700E30FA83C5}" type="datetimeFigureOut">
              <a:rPr lang="zh-CN" altLang="en-US" smtClean="0"/>
              <a:t>2025/3/7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8E72488F-406F-5367-C102-DE5C59380345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15C380B3-3E4A-2D9D-F12D-4C1BF6DF752A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0E8C46C-210E-4986-8B21-85BBBC61F08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29405106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" name="图片 9">
            <a:extLst>
              <a:ext uri="{FF2B5EF4-FFF2-40B4-BE49-F238E27FC236}">
                <a16:creationId xmlns:a16="http://schemas.microsoft.com/office/drawing/2014/main" id="{4F130DEE-CCA6-A4BB-B176-844914FBB35D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020998" y="991713"/>
            <a:ext cx="1365180" cy="1610486"/>
          </a:xfrm>
          <a:prstGeom prst="rect">
            <a:avLst/>
          </a:prstGeom>
        </p:spPr>
      </p:pic>
      <p:pic>
        <p:nvPicPr>
          <p:cNvPr id="7" name="图片 6">
            <a:extLst>
              <a:ext uri="{FF2B5EF4-FFF2-40B4-BE49-F238E27FC236}">
                <a16:creationId xmlns:a16="http://schemas.microsoft.com/office/drawing/2014/main" id="{751536F9-FBB3-EDEC-F663-E22D13630A1F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592354" y="721111"/>
            <a:ext cx="2006963" cy="1862253"/>
          </a:xfrm>
          <a:prstGeom prst="rect">
            <a:avLst/>
          </a:prstGeom>
        </p:spPr>
      </p:pic>
      <p:pic>
        <p:nvPicPr>
          <p:cNvPr id="11" name="图片 10">
            <a:extLst>
              <a:ext uri="{FF2B5EF4-FFF2-40B4-BE49-F238E27FC236}">
                <a16:creationId xmlns:a16="http://schemas.microsoft.com/office/drawing/2014/main" id="{6F7B7487-8A75-93FD-A7F9-17508AE7A8AD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599317" y="1652237"/>
            <a:ext cx="817962" cy="866078"/>
          </a:xfrm>
          <a:prstGeom prst="rect">
            <a:avLst/>
          </a:prstGeom>
        </p:spPr>
      </p:pic>
      <p:sp>
        <p:nvSpPr>
          <p:cNvPr id="22" name="箭头: 右 21">
            <a:extLst>
              <a:ext uri="{FF2B5EF4-FFF2-40B4-BE49-F238E27FC236}">
                <a16:creationId xmlns:a16="http://schemas.microsoft.com/office/drawing/2014/main" id="{4A242555-8281-CB39-6166-AF215C691BE7}"/>
              </a:ext>
            </a:extLst>
          </p:cNvPr>
          <p:cNvSpPr/>
          <p:nvPr/>
        </p:nvSpPr>
        <p:spPr>
          <a:xfrm>
            <a:off x="2975742" y="1435863"/>
            <a:ext cx="1742417" cy="789379"/>
          </a:xfrm>
          <a:prstGeom prst="rightArrow">
            <a:avLst/>
          </a:prstGeom>
          <a:solidFill>
            <a:srgbClr val="F5927C"/>
          </a:solidFill>
          <a:ln w="19050"/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>
              <a:lnSpc>
                <a:spcPts val="1200"/>
              </a:lnSpc>
            </a:pPr>
            <a:r>
              <a:rPr lang="en-US" altLang="zh-CN" sz="1400" b="1" dirty="0">
                <a:solidFill>
                  <a:schemeClr val="tx1"/>
                </a:solidFill>
              </a:rPr>
              <a:t>Feed additives and medicine</a:t>
            </a:r>
            <a:endParaRPr lang="zh-CN" altLang="en-US" sz="1400" b="1" dirty="0">
              <a:solidFill>
                <a:schemeClr val="tx1"/>
              </a:solidFill>
            </a:endParaRPr>
          </a:p>
        </p:txBody>
      </p:sp>
      <p:sp>
        <p:nvSpPr>
          <p:cNvPr id="24" name="箭头: 右 23">
            <a:extLst>
              <a:ext uri="{FF2B5EF4-FFF2-40B4-BE49-F238E27FC236}">
                <a16:creationId xmlns:a16="http://schemas.microsoft.com/office/drawing/2014/main" id="{7C8F2939-C070-7D6D-E4D0-3410B6F7F872}"/>
              </a:ext>
            </a:extLst>
          </p:cNvPr>
          <p:cNvSpPr/>
          <p:nvPr/>
        </p:nvSpPr>
        <p:spPr>
          <a:xfrm rot="2777333">
            <a:off x="7252914" y="2781991"/>
            <a:ext cx="1931272" cy="914268"/>
          </a:xfrm>
          <a:prstGeom prst="rightArrow">
            <a:avLst/>
          </a:prstGeom>
          <a:solidFill>
            <a:srgbClr val="F5927C"/>
          </a:solidFill>
          <a:ln w="19050"/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zh-CN" sz="1600" b="1" dirty="0">
                <a:solidFill>
                  <a:schemeClr val="tx1"/>
                </a:solidFill>
              </a:rPr>
              <a:t>16s rRNA sequencing</a:t>
            </a:r>
            <a:endParaRPr lang="zh-CN" altLang="en-US" sz="1600" b="1" dirty="0">
              <a:solidFill>
                <a:schemeClr val="tx1"/>
              </a:solidFill>
            </a:endParaRPr>
          </a:p>
        </p:txBody>
      </p:sp>
      <p:sp>
        <p:nvSpPr>
          <p:cNvPr id="27" name="箭头: 右 26">
            <a:extLst>
              <a:ext uri="{FF2B5EF4-FFF2-40B4-BE49-F238E27FC236}">
                <a16:creationId xmlns:a16="http://schemas.microsoft.com/office/drawing/2014/main" id="{7F1A867A-F680-5E30-B90C-6D35A0AFFF6F}"/>
              </a:ext>
            </a:extLst>
          </p:cNvPr>
          <p:cNvSpPr/>
          <p:nvPr/>
        </p:nvSpPr>
        <p:spPr>
          <a:xfrm>
            <a:off x="7572933" y="1435863"/>
            <a:ext cx="1365180" cy="722189"/>
          </a:xfrm>
          <a:prstGeom prst="rightArrow">
            <a:avLst/>
          </a:prstGeom>
          <a:solidFill>
            <a:srgbClr val="F5927C"/>
          </a:solidFill>
          <a:ln w="19050"/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zh-CN" b="1" dirty="0">
                <a:solidFill>
                  <a:schemeClr val="tx1"/>
                </a:solidFill>
              </a:rPr>
              <a:t>influence</a:t>
            </a:r>
            <a:endParaRPr lang="zh-CN" altLang="en-US" b="1" dirty="0">
              <a:solidFill>
                <a:schemeClr val="tx1"/>
              </a:solidFill>
            </a:endParaRPr>
          </a:p>
        </p:txBody>
      </p:sp>
      <p:pic>
        <p:nvPicPr>
          <p:cNvPr id="31" name="图片 30">
            <a:extLst>
              <a:ext uri="{FF2B5EF4-FFF2-40B4-BE49-F238E27FC236}">
                <a16:creationId xmlns:a16="http://schemas.microsoft.com/office/drawing/2014/main" id="{25B0594F-3567-447F-8884-3B01BBC91E94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719737" y="1214619"/>
            <a:ext cx="1254921" cy="1214871"/>
          </a:xfrm>
          <a:prstGeom prst="rect">
            <a:avLst/>
          </a:prstGeom>
        </p:spPr>
      </p:pic>
      <p:sp>
        <p:nvSpPr>
          <p:cNvPr id="43" name="箭头: 左 42">
            <a:extLst>
              <a:ext uri="{FF2B5EF4-FFF2-40B4-BE49-F238E27FC236}">
                <a16:creationId xmlns:a16="http://schemas.microsoft.com/office/drawing/2014/main" id="{8988EAA3-EFF5-C38D-CB1A-EF5AC221D4CF}"/>
              </a:ext>
            </a:extLst>
          </p:cNvPr>
          <p:cNvSpPr/>
          <p:nvPr/>
        </p:nvSpPr>
        <p:spPr>
          <a:xfrm rot="19065285">
            <a:off x="5065484" y="2845981"/>
            <a:ext cx="1897886" cy="883912"/>
          </a:xfrm>
          <a:prstGeom prst="leftArrow">
            <a:avLst/>
          </a:prstGeom>
          <a:solidFill>
            <a:srgbClr val="F5927C"/>
          </a:solidFill>
          <a:ln w="19050"/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zh-CN" sz="1600" b="1" dirty="0">
                <a:solidFill>
                  <a:schemeClr val="tx1"/>
                </a:solidFill>
              </a:rPr>
              <a:t>HT-qPCR</a:t>
            </a:r>
            <a:endParaRPr lang="zh-CN" altLang="en-US" sz="1600" b="1" dirty="0">
              <a:solidFill>
                <a:schemeClr val="tx1"/>
              </a:solidFill>
            </a:endParaRPr>
          </a:p>
        </p:txBody>
      </p:sp>
      <p:sp>
        <p:nvSpPr>
          <p:cNvPr id="50" name="文本框 49">
            <a:extLst>
              <a:ext uri="{FF2B5EF4-FFF2-40B4-BE49-F238E27FC236}">
                <a16:creationId xmlns:a16="http://schemas.microsoft.com/office/drawing/2014/main" id="{FB472AA1-DBE3-A4C5-8969-3BA678DF0B28}"/>
              </a:ext>
            </a:extLst>
          </p:cNvPr>
          <p:cNvSpPr txBox="1"/>
          <p:nvPr/>
        </p:nvSpPr>
        <p:spPr>
          <a:xfrm>
            <a:off x="4069651" y="5906056"/>
            <a:ext cx="2460704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400" b="1" dirty="0"/>
              <a:t>ARG profiles</a:t>
            </a:r>
            <a:endParaRPr lang="zh-CN" altLang="en-US" sz="2400" b="1" dirty="0"/>
          </a:p>
        </p:txBody>
      </p:sp>
      <p:sp>
        <p:nvSpPr>
          <p:cNvPr id="53" name="文本框 52">
            <a:extLst>
              <a:ext uri="{FF2B5EF4-FFF2-40B4-BE49-F238E27FC236}">
                <a16:creationId xmlns:a16="http://schemas.microsoft.com/office/drawing/2014/main" id="{ED023B14-4712-DB7F-036E-5D7E2DB07EF5}"/>
              </a:ext>
            </a:extLst>
          </p:cNvPr>
          <p:cNvSpPr txBox="1"/>
          <p:nvPr/>
        </p:nvSpPr>
        <p:spPr>
          <a:xfrm>
            <a:off x="7572312" y="5906056"/>
            <a:ext cx="3287892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400" b="1" dirty="0"/>
              <a:t>Microbial community</a:t>
            </a:r>
            <a:endParaRPr lang="zh-CN" altLang="en-US" sz="2400" b="1" dirty="0"/>
          </a:p>
        </p:txBody>
      </p:sp>
      <p:pic>
        <p:nvPicPr>
          <p:cNvPr id="3" name="图片 2">
            <a:extLst>
              <a:ext uri="{FF2B5EF4-FFF2-40B4-BE49-F238E27FC236}">
                <a16:creationId xmlns:a16="http://schemas.microsoft.com/office/drawing/2014/main" id="{BCDFF20D-4EA4-7BD3-09E9-24B536728E25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7340370" y="4058051"/>
            <a:ext cx="3751775" cy="1930298"/>
          </a:xfrm>
          <a:prstGeom prst="rect">
            <a:avLst/>
          </a:prstGeom>
        </p:spPr>
      </p:pic>
      <p:pic>
        <p:nvPicPr>
          <p:cNvPr id="5" name="图片 4">
            <a:extLst>
              <a:ext uri="{FF2B5EF4-FFF2-40B4-BE49-F238E27FC236}">
                <a16:creationId xmlns:a16="http://schemas.microsoft.com/office/drawing/2014/main" id="{97809514-7627-2ABB-A2C0-29120B6564B0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3754661" y="4099793"/>
            <a:ext cx="2414751" cy="1846814"/>
          </a:xfrm>
          <a:prstGeom prst="rect">
            <a:avLst/>
          </a:prstGeom>
        </p:spPr>
      </p:pic>
      <p:pic>
        <p:nvPicPr>
          <p:cNvPr id="8" name="图片 7">
            <a:extLst>
              <a:ext uri="{FF2B5EF4-FFF2-40B4-BE49-F238E27FC236}">
                <a16:creationId xmlns:a16="http://schemas.microsoft.com/office/drawing/2014/main" id="{4D480EFB-12DD-BD23-40B6-15600D748424}"/>
              </a:ext>
            </a:extLst>
          </p:cNvPr>
          <p:cNvPicPr>
            <a:picLocks noChangeAspect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607440" y="1589248"/>
            <a:ext cx="608577" cy="41541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42356212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84</TotalTime>
  <Words>13</Words>
  <Application>Microsoft Office PowerPoint</Application>
  <PresentationFormat>宽屏</PresentationFormat>
  <Paragraphs>6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5" baseType="lpstr">
      <vt:lpstr>等线</vt:lpstr>
      <vt:lpstr>等线 Light</vt:lpstr>
      <vt:lpstr>Arial</vt:lpstr>
      <vt:lpstr>Office 主题​​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一凡 牛</dc:creator>
  <cp:lastModifiedBy>一凡 牛</cp:lastModifiedBy>
  <cp:revision>4</cp:revision>
  <dcterms:created xsi:type="dcterms:W3CDTF">2025-03-05T02:13:55Z</dcterms:created>
  <dcterms:modified xsi:type="dcterms:W3CDTF">2025-03-07T08:15:48Z</dcterms:modified>
</cp:coreProperties>
</file>